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4674"/>
  </p:normalViewPr>
  <p:slideViewPr>
    <p:cSldViewPr snapToGrid="0" snapToObjects="1">
      <p:cViewPr varScale="1">
        <p:scale>
          <a:sx n="110" d="100"/>
          <a:sy n="110" d="100"/>
        </p:scale>
        <p:origin x="158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yasakahitoshi/Dropbox/Microorganisms&#25237;&#31295;/Microorganism&#29992;&#24863;&#26579;&#23455;&#39443;&#12486;&#12441;&#12540;&#12479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095980476911501"/>
          <c:y val="6.7952976958311123E-2"/>
          <c:w val="0.79475396244074104"/>
          <c:h val="0.78170414310627301"/>
        </c:manualLayout>
      </c:layout>
      <c:lineChart>
        <c:grouping val="standard"/>
        <c:varyColors val="0"/>
        <c:ser>
          <c:idx val="0"/>
          <c:order val="0"/>
          <c:tx>
            <c:strRef>
              <c:f>Sheet1!$K$13</c:f>
              <c:strCache>
                <c:ptCount val="1"/>
                <c:pt idx="0">
                  <c:v>Control</c:v>
                </c:pt>
              </c:strCache>
            </c:strRef>
          </c:tx>
          <c:spPr>
            <a:ln w="2222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2"/>
            <c:spPr>
              <a:noFill/>
              <a:ln w="9525">
                <a:solidFill>
                  <a:schemeClr val="tx1"/>
                </a:solidFill>
                <a:round/>
              </a:ln>
              <a:effectLst/>
            </c:spPr>
          </c:marker>
          <c:cat>
            <c:numRef>
              <c:f>Sheet1!$J$14:$J$25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</c:numCache>
            </c:numRef>
          </c:cat>
          <c:val>
            <c:numRef>
              <c:f>Sheet1!$K$14:$K$25</c:f>
              <c:numCache>
                <c:formatCode>#,##0_);[Red]\(#,##0\)</c:formatCode>
                <c:ptCount val="12"/>
                <c:pt idx="0">
                  <c:v>100</c:v>
                </c:pt>
                <c:pt idx="1">
                  <c:v>55.555555555555557</c:v>
                </c:pt>
                <c:pt idx="2">
                  <c:v>55.555555555555557</c:v>
                </c:pt>
                <c:pt idx="3">
                  <c:v>55.555555555555557</c:v>
                </c:pt>
                <c:pt idx="4">
                  <c:v>55.555555555555557</c:v>
                </c:pt>
                <c:pt idx="5">
                  <c:v>55.555555555555557</c:v>
                </c:pt>
                <c:pt idx="6">
                  <c:v>44.444444444444443</c:v>
                </c:pt>
                <c:pt idx="7">
                  <c:v>22.222222222222221</c:v>
                </c:pt>
                <c:pt idx="8">
                  <c:v>22.222222222222221</c:v>
                </c:pt>
                <c:pt idx="9">
                  <c:v>22</c:v>
                </c:pt>
                <c:pt idx="10">
                  <c:v>22</c:v>
                </c:pt>
                <c:pt idx="11">
                  <c:v>2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A47-0C4C-9F32-EEB14412FFBE}"/>
            </c:ext>
          </c:extLst>
        </c:ser>
        <c:ser>
          <c:idx val="2"/>
          <c:order val="1"/>
          <c:tx>
            <c:strRef>
              <c:f>Sheet1!$L$13</c:f>
              <c:strCache>
                <c:ptCount val="1"/>
                <c:pt idx="0">
                  <c:v>KKMI01(生)</c:v>
                </c:pt>
              </c:strCache>
            </c:strRef>
          </c:tx>
          <c:spPr>
            <a:ln w="2222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2"/>
            <c:spPr>
              <a:solidFill>
                <a:schemeClr val="tx1"/>
              </a:solidFill>
              <a:ln w="9525">
                <a:solidFill>
                  <a:schemeClr val="dk1">
                    <a:tint val="75000"/>
                  </a:schemeClr>
                </a:solidFill>
                <a:round/>
              </a:ln>
              <a:effectLst/>
            </c:spPr>
          </c:marker>
          <c:cat>
            <c:numRef>
              <c:f>Sheet1!$J$14:$J$25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</c:numCache>
            </c:numRef>
          </c:cat>
          <c:val>
            <c:numRef>
              <c:f>Sheet1!$L$14:$L$25</c:f>
              <c:numCache>
                <c:formatCode>#,##0_);[Red]\(#,##0\)</c:formatCode>
                <c:ptCount val="12"/>
                <c:pt idx="0">
                  <c:v>100</c:v>
                </c:pt>
                <c:pt idx="1">
                  <c:v>100</c:v>
                </c:pt>
                <c:pt idx="2">
                  <c:v>86</c:v>
                </c:pt>
                <c:pt idx="3">
                  <c:v>57</c:v>
                </c:pt>
                <c:pt idx="4">
                  <c:v>57</c:v>
                </c:pt>
                <c:pt idx="5">
                  <c:v>57</c:v>
                </c:pt>
                <c:pt idx="6">
                  <c:v>57</c:v>
                </c:pt>
                <c:pt idx="7">
                  <c:v>57</c:v>
                </c:pt>
                <c:pt idx="8">
                  <c:v>57</c:v>
                </c:pt>
                <c:pt idx="9">
                  <c:v>57</c:v>
                </c:pt>
                <c:pt idx="10">
                  <c:v>57</c:v>
                </c:pt>
                <c:pt idx="11">
                  <c:v>5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A47-0C4C-9F32-EEB14412FFBE}"/>
            </c:ext>
          </c:extLst>
        </c:ser>
        <c:ser>
          <c:idx val="3"/>
          <c:order val="2"/>
          <c:tx>
            <c:strRef>
              <c:f>Sheet1!$M$13</c:f>
              <c:strCache>
                <c:ptCount val="1"/>
                <c:pt idx="0">
                  <c:v>KKMI01(死)</c:v>
                </c:pt>
              </c:strCache>
            </c:strRef>
          </c:tx>
          <c:spPr>
            <a:ln w="22225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12"/>
            <c:spPr>
              <a:noFill/>
              <a:ln w="9525">
                <a:solidFill>
                  <a:schemeClr val="tx1"/>
                </a:solidFill>
                <a:round/>
              </a:ln>
              <a:effectLst/>
            </c:spPr>
          </c:marker>
          <c:cat>
            <c:numRef>
              <c:f>Sheet1!$J$14:$J$25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</c:numCache>
            </c:numRef>
          </c:cat>
          <c:val>
            <c:numRef>
              <c:f>Sheet1!$M$14:$M$25</c:f>
              <c:numCache>
                <c:formatCode>#,##0_);[Red]\(#,##0\)</c:formatCode>
                <c:ptCount val="12"/>
                <c:pt idx="0">
                  <c:v>100</c:v>
                </c:pt>
                <c:pt idx="1">
                  <c:v>88.888888888888886</c:v>
                </c:pt>
                <c:pt idx="2">
                  <c:v>88.888888888888886</c:v>
                </c:pt>
                <c:pt idx="3">
                  <c:v>55.555555555555557</c:v>
                </c:pt>
                <c:pt idx="4">
                  <c:v>55.555555555555557</c:v>
                </c:pt>
                <c:pt idx="5">
                  <c:v>55.555555555555557</c:v>
                </c:pt>
                <c:pt idx="6">
                  <c:v>55.555555555555557</c:v>
                </c:pt>
                <c:pt idx="7">
                  <c:v>55.555555555555557</c:v>
                </c:pt>
                <c:pt idx="8">
                  <c:v>55.555555555555557</c:v>
                </c:pt>
                <c:pt idx="9">
                  <c:v>56</c:v>
                </c:pt>
                <c:pt idx="10">
                  <c:v>56</c:v>
                </c:pt>
                <c:pt idx="11">
                  <c:v>5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9A47-0C4C-9F32-EEB14412FFB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970439184"/>
        <c:axId val="-934322368"/>
      </c:lineChart>
      <c:catAx>
        <c:axId val="-970439184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cap="all" spc="120" normalizeH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934322368"/>
        <c:crosses val="autoZero"/>
        <c:auto val="1"/>
        <c:lblAlgn val="ctr"/>
        <c:lblOffset val="100"/>
        <c:noMultiLvlLbl val="0"/>
      </c:catAx>
      <c:valAx>
        <c:axId val="-934322368"/>
        <c:scaling>
          <c:orientation val="minMax"/>
          <c:max val="110"/>
          <c:min val="0"/>
        </c:scaling>
        <c:delete val="0"/>
        <c:axPos val="l"/>
        <c:numFmt formatCode="#,##0_);[Red]\(#,##0\)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970439184"/>
        <c:crosses val="autoZero"/>
        <c:crossBetween val="between"/>
        <c:majorUnit val="2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lt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3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FF354-C9CE-0741-9D25-1C6F0A05724B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3DA77-123E-4E47-BF2A-7ABD6E97DC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47848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FF354-C9CE-0741-9D25-1C6F0A05724B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3DA77-123E-4E47-BF2A-7ABD6E97DC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84533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FF354-C9CE-0741-9D25-1C6F0A05724B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3DA77-123E-4E47-BF2A-7ABD6E97DC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20068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FF354-C9CE-0741-9D25-1C6F0A05724B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3DA77-123E-4E47-BF2A-7ABD6E97DC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8947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FF354-C9CE-0741-9D25-1C6F0A05724B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3DA77-123E-4E47-BF2A-7ABD6E97DC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84029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FF354-C9CE-0741-9D25-1C6F0A05724B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3DA77-123E-4E47-BF2A-7ABD6E97DC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10279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FF354-C9CE-0741-9D25-1C6F0A05724B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3DA77-123E-4E47-BF2A-7ABD6E97DC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80425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FF354-C9CE-0741-9D25-1C6F0A05724B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3DA77-123E-4E47-BF2A-7ABD6E97DC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23966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FF354-C9CE-0741-9D25-1C6F0A05724B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3DA77-123E-4E47-BF2A-7ABD6E97DC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9108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FF354-C9CE-0741-9D25-1C6F0A05724B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3DA77-123E-4E47-BF2A-7ABD6E97DC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0457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FF354-C9CE-0741-9D25-1C6F0A05724B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3DA77-123E-4E47-BF2A-7ABD6E97DC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37917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7FF354-C9CE-0741-9D25-1C6F0A05724B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F3DA77-123E-4E47-BF2A-7ABD6E97DC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50174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60CF8BE2-5BBB-C842-AF59-D316FAFE832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64399477"/>
              </p:ext>
            </p:extLst>
          </p:nvPr>
        </p:nvGraphicFramePr>
        <p:xfrm>
          <a:off x="896845" y="141513"/>
          <a:ext cx="6734041" cy="49244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F0A4FF8A-2467-1E48-A3BD-09F34C49E162}"/>
              </a:ext>
            </a:extLst>
          </p:cNvPr>
          <p:cNvSpPr/>
          <p:nvPr/>
        </p:nvSpPr>
        <p:spPr>
          <a:xfrm>
            <a:off x="1051893" y="5383420"/>
            <a:ext cx="787282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977900" indent="-977900"/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2:</a:t>
            </a:r>
            <a:r>
              <a:rPr lang="en-US" altLang="ja-JP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vival rate of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japonicus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ter challenge with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brio </a:t>
            </a:r>
            <a:r>
              <a:rPr lang="en-US" altLang="ja-JP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ginolyticus</a:t>
            </a:r>
            <a:endParaRPr lang="en-US" altLang="ja-JP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1113" indent="-11113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rimp were fed with feed containing PNSB cells (live or dead) and no supplement (control) for 7 days, and challenged with </a:t>
            </a:r>
            <a:r>
              <a:rPr lang="en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. </a:t>
            </a:r>
            <a:r>
              <a:rPr lang="en" altLang="ja-JP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ginolyticus</a:t>
            </a:r>
            <a:r>
              <a:rPr lang="en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s of shrimp at day 0 were 9 (control), 7 (live PNSB) and 9 (dead PNSB).</a:t>
            </a:r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4373E64-0561-0E4C-8AFC-7D9F4C3E43DD}"/>
              </a:ext>
            </a:extLst>
          </p:cNvPr>
          <p:cNvSpPr txBox="1"/>
          <p:nvPr/>
        </p:nvSpPr>
        <p:spPr>
          <a:xfrm rot="16200000">
            <a:off x="-133564" y="2344885"/>
            <a:ext cx="24609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urvival rate (%)</a:t>
            </a:r>
            <a:endParaRPr kumimoji="1" lang="ja-JP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FAC2530-B219-D647-B4BA-0859B253FF7D}"/>
              </a:ext>
            </a:extLst>
          </p:cNvPr>
          <p:cNvSpPr txBox="1"/>
          <p:nvPr/>
        </p:nvSpPr>
        <p:spPr>
          <a:xfrm>
            <a:off x="3817998" y="4831058"/>
            <a:ext cx="17986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Time (days)</a:t>
            </a:r>
            <a:endParaRPr kumimoji="1" lang="ja-JP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円/楕円 10">
            <a:extLst>
              <a:ext uri="{FF2B5EF4-FFF2-40B4-BE49-F238E27FC236}">
                <a16:creationId xmlns:a16="http://schemas.microsoft.com/office/drawing/2014/main" id="{5662943D-5F18-CF44-B330-31844EC464B0}"/>
              </a:ext>
            </a:extLst>
          </p:cNvPr>
          <p:cNvSpPr/>
          <p:nvPr/>
        </p:nvSpPr>
        <p:spPr>
          <a:xfrm>
            <a:off x="4588594" y="573497"/>
            <a:ext cx="157164" cy="163285"/>
          </a:xfrm>
          <a:prstGeom prst="ellipse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円/楕円 11">
            <a:extLst>
              <a:ext uri="{FF2B5EF4-FFF2-40B4-BE49-F238E27FC236}">
                <a16:creationId xmlns:a16="http://schemas.microsoft.com/office/drawing/2014/main" id="{9094D2F8-B3AD-3545-91E6-2FE422540B13}"/>
              </a:ext>
            </a:extLst>
          </p:cNvPr>
          <p:cNvSpPr/>
          <p:nvPr/>
        </p:nvSpPr>
        <p:spPr>
          <a:xfrm>
            <a:off x="5230855" y="584383"/>
            <a:ext cx="157164" cy="163285"/>
          </a:xfrm>
          <a:prstGeom prst="ellipse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円/楕円 12">
            <a:extLst>
              <a:ext uri="{FF2B5EF4-FFF2-40B4-BE49-F238E27FC236}">
                <a16:creationId xmlns:a16="http://schemas.microsoft.com/office/drawing/2014/main" id="{FBD92E9B-A3BB-904F-8AB8-64F26E9DFB70}"/>
              </a:ext>
            </a:extLst>
          </p:cNvPr>
          <p:cNvSpPr/>
          <p:nvPr/>
        </p:nvSpPr>
        <p:spPr>
          <a:xfrm>
            <a:off x="4599480" y="951740"/>
            <a:ext cx="157164" cy="163285"/>
          </a:xfrm>
          <a:prstGeom prst="ellipse">
            <a:avLst/>
          </a:prstGeom>
          <a:solidFill>
            <a:schemeClr val="tx1"/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円/楕円 13">
            <a:extLst>
              <a:ext uri="{FF2B5EF4-FFF2-40B4-BE49-F238E27FC236}">
                <a16:creationId xmlns:a16="http://schemas.microsoft.com/office/drawing/2014/main" id="{1544AD89-7047-8F47-BDC9-1FE1C3D68C57}"/>
              </a:ext>
            </a:extLst>
          </p:cNvPr>
          <p:cNvSpPr/>
          <p:nvPr/>
        </p:nvSpPr>
        <p:spPr>
          <a:xfrm>
            <a:off x="5241741" y="962626"/>
            <a:ext cx="157164" cy="163285"/>
          </a:xfrm>
          <a:prstGeom prst="ellipse">
            <a:avLst/>
          </a:prstGeom>
          <a:solidFill>
            <a:schemeClr val="tx1"/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三角形 14">
            <a:extLst>
              <a:ext uri="{FF2B5EF4-FFF2-40B4-BE49-F238E27FC236}">
                <a16:creationId xmlns:a16="http://schemas.microsoft.com/office/drawing/2014/main" id="{E0147995-8E85-804B-918C-B3AAC0E0A9B9}"/>
              </a:ext>
            </a:extLst>
          </p:cNvPr>
          <p:cNvSpPr/>
          <p:nvPr/>
        </p:nvSpPr>
        <p:spPr>
          <a:xfrm>
            <a:off x="4593358" y="1373527"/>
            <a:ext cx="152400" cy="174172"/>
          </a:xfrm>
          <a:prstGeom prst="triangle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三角形 15">
            <a:extLst>
              <a:ext uri="{FF2B5EF4-FFF2-40B4-BE49-F238E27FC236}">
                <a16:creationId xmlns:a16="http://schemas.microsoft.com/office/drawing/2014/main" id="{9C652444-5CAD-7549-972A-14ADE6B15363}"/>
              </a:ext>
            </a:extLst>
          </p:cNvPr>
          <p:cNvSpPr/>
          <p:nvPr/>
        </p:nvSpPr>
        <p:spPr>
          <a:xfrm>
            <a:off x="5246502" y="1362639"/>
            <a:ext cx="152400" cy="174172"/>
          </a:xfrm>
          <a:prstGeom prst="triangle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71E22B16-488B-3D45-9E30-1F4B952CC47D}"/>
              </a:ext>
            </a:extLst>
          </p:cNvPr>
          <p:cNvCxnSpPr/>
          <p:nvPr/>
        </p:nvCxnSpPr>
        <p:spPr>
          <a:xfrm>
            <a:off x="4778416" y="660582"/>
            <a:ext cx="419781" cy="5443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0244D321-D85D-E444-BDF3-8543ACD80753}"/>
              </a:ext>
            </a:extLst>
          </p:cNvPr>
          <p:cNvCxnSpPr/>
          <p:nvPr/>
        </p:nvCxnSpPr>
        <p:spPr>
          <a:xfrm>
            <a:off x="4778418" y="1049711"/>
            <a:ext cx="419781" cy="5443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0C319D69-3E15-1F47-BA0A-72E3CAD12FD9}"/>
              </a:ext>
            </a:extLst>
          </p:cNvPr>
          <p:cNvCxnSpPr/>
          <p:nvPr/>
        </p:nvCxnSpPr>
        <p:spPr>
          <a:xfrm>
            <a:off x="4800189" y="1482384"/>
            <a:ext cx="419781" cy="5443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89FFE7F-1AE3-9A47-BB47-CC5F1926EE1D}"/>
              </a:ext>
            </a:extLst>
          </p:cNvPr>
          <p:cNvSpPr txBox="1"/>
          <p:nvPr/>
        </p:nvSpPr>
        <p:spPr>
          <a:xfrm>
            <a:off x="5473434" y="478637"/>
            <a:ext cx="8451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7BF510C8-0DF2-744A-97E4-8196D6971FD5}"/>
              </a:ext>
            </a:extLst>
          </p:cNvPr>
          <p:cNvSpPr txBox="1"/>
          <p:nvPr/>
        </p:nvSpPr>
        <p:spPr>
          <a:xfrm>
            <a:off x="5485699" y="878652"/>
            <a:ext cx="17668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PNSB cells (live)</a:t>
            </a:r>
            <a:r>
              <a:rPr lang="ja-JP" altLang="ja-JP" sz="16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D5953DB-4D08-5B42-8B9F-00805F6BBAF1}"/>
              </a:ext>
            </a:extLst>
          </p:cNvPr>
          <p:cNvSpPr txBox="1"/>
          <p:nvPr/>
        </p:nvSpPr>
        <p:spPr>
          <a:xfrm>
            <a:off x="5496584" y="1297718"/>
            <a:ext cx="19159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PNSB cells (dead)</a:t>
            </a:r>
            <a:r>
              <a:rPr lang="ja-JP" altLang="ja-JP" sz="16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78803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43A1275-7BEC-924D-A1F7-C9C83731AECE}"/>
              </a:ext>
            </a:extLst>
          </p:cNvPr>
          <p:cNvSpPr txBox="1"/>
          <p:nvPr/>
        </p:nvSpPr>
        <p:spPr>
          <a:xfrm>
            <a:off x="446313" y="612844"/>
            <a:ext cx="8251373" cy="563231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al procedure</a:t>
            </a:r>
          </a:p>
          <a:p>
            <a:endParaRPr lang="en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i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brio </a:t>
            </a:r>
            <a:r>
              <a:rPr lang="en-US" altLang="ja-JP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 and culture condition</a:t>
            </a:r>
            <a:endParaRPr lang="en" altLang="ja-JP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shrimp pathogenic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brio 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, </a:t>
            </a:r>
            <a:r>
              <a:rPr lang="en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. </a:t>
            </a:r>
            <a:r>
              <a:rPr lang="en" altLang="ja-JP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ginolyticus</a:t>
            </a:r>
            <a:r>
              <a:rPr lang="en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d in this study was a kind gift of Kagoshima Prefectural Fisheries Technology and Development Center (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busuki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Kagoshima, Japan).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16S rRNA sequence of this strain was identical to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brio </a:t>
            </a:r>
            <a:r>
              <a:rPr lang="en-US" altLang="ja-JP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ginolyticus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 GS_MYPK1 (GenBank/EMBL/DDBJ accession number: CP054701). The </a:t>
            </a:r>
            <a:r>
              <a:rPr lang="en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. </a:t>
            </a:r>
            <a:r>
              <a:rPr lang="en" altLang="ja-JP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ginolyticus</a:t>
            </a:r>
            <a:r>
              <a:rPr lang="en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were cultured in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BRC No.325 medium (Biological Resource Center, NITE) at 27 °C. </a:t>
            </a:r>
          </a:p>
          <a:p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PNSB treatment of shrimp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mall-scale aquaria experiments were performed same as described in 2.2. of Materials and Methods section of main text. The average body weight of shrimp was about 3 g. The shrimp were fed with the feed containing live (10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fu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/g) or dead (10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quivalent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fu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/g)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. </a:t>
            </a:r>
            <a:r>
              <a:rPr lang="en-US" altLang="ja-JP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lfidophilum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KMI01 cells for 7 days.</a:t>
            </a:r>
          </a:p>
          <a:p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" altLang="ja-JP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llenge test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n days after the start of the feeding period, shrimp were challenged by immersion in seawater containing 10</a:t>
            </a:r>
            <a:r>
              <a:rPr lang="en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fu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 of </a:t>
            </a:r>
            <a:r>
              <a:rPr lang="en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. </a:t>
            </a:r>
            <a:r>
              <a:rPr lang="en" altLang="ja-JP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ginolyticus</a:t>
            </a:r>
            <a:r>
              <a:rPr lang="en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6 hours. After challenge, all the shrimp were fed with standard feed (no PNSB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5438728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4</TotalTime>
  <Words>292</Words>
  <Application>Microsoft Macintosh PowerPoint</Application>
  <PresentationFormat>画面に合わせる (4:3)</PresentationFormat>
  <Paragraphs>17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宮坂均</dc:creator>
  <cp:lastModifiedBy>宮坂 研究室</cp:lastModifiedBy>
  <cp:revision>10</cp:revision>
  <dcterms:created xsi:type="dcterms:W3CDTF">2022-01-14T01:45:35Z</dcterms:created>
  <dcterms:modified xsi:type="dcterms:W3CDTF">2022-01-16T02:32:43Z</dcterms:modified>
</cp:coreProperties>
</file>